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6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40CCAF-778E-46A4-A79C-E434E65D801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FD8893-4F58-4189-8EF1-2AFB79ED6D9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FC2315-19FA-4722-9BE5-66C708F5C91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405A4B-3779-4AD9-81B9-D3E51135E81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2EEC72-BD02-4E80-8265-1F73010871E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378437-5E62-4D0D-8449-5AE18F96FE7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DDC6FE-CBAB-4273-ADF5-86066F2B41C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1343DA-1F34-4438-BA35-B705FDA8796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B37B50-34DF-4C9E-A32E-6E903D4A7B2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310205-448D-41E5-BA0C-2BA14021C6F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F4C0BF-AFE0-4306-85A8-E7497E9E82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84AAB1-39BD-4F41-B94D-D066881D95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FF0F6F0-31D4-4EEA-94FD-2ADC632F58AA}" type="slidenum">
              <a:rPr b="0" lang="zh-TW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511200"/>
            <a:ext cx="6153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굴림"/>
              </a:rPr>
              <a:t>a)  PL spectra (stability) of CdTe nanoparticles in wat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2465280" y="1125360"/>
            <a:ext cx="1755720" cy="1317600"/>
            <a:chOff x="2465280" y="1125360"/>
            <a:chExt cx="1755720" cy="1317600"/>
          </a:xfrm>
        </p:grpSpPr>
        <p:sp>
          <p:nvSpPr>
            <p:cNvPr id="43" name=""/>
            <p:cNvSpPr/>
            <p:nvPr/>
          </p:nvSpPr>
          <p:spPr>
            <a:xfrm>
              <a:off x="3610800" y="1201680"/>
              <a:ext cx="446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wate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4" name="" descr=""/>
            <p:cNvPicPr/>
            <p:nvPr/>
          </p:nvPicPr>
          <p:blipFill>
            <a:blip r:embed="rId1"/>
            <a:stretch/>
          </p:blipFill>
          <p:spPr>
            <a:xfrm>
              <a:off x="2465280" y="1125360"/>
              <a:ext cx="1755720" cy="131760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45" name=""/>
          <p:cNvGrpSpPr/>
          <p:nvPr/>
        </p:nvGrpSpPr>
        <p:grpSpPr>
          <a:xfrm>
            <a:off x="2465280" y="5329080"/>
            <a:ext cx="1755720" cy="1317600"/>
            <a:chOff x="2465280" y="5329080"/>
            <a:chExt cx="1755720" cy="1317600"/>
          </a:xfrm>
        </p:grpSpPr>
        <p:pic>
          <p:nvPicPr>
            <p:cNvPr id="46" name="" descr=""/>
            <p:cNvPicPr/>
            <p:nvPr/>
          </p:nvPicPr>
          <p:blipFill>
            <a:blip r:embed="rId2"/>
            <a:stretch/>
          </p:blipFill>
          <p:spPr>
            <a:xfrm>
              <a:off x="2465280" y="5329080"/>
              <a:ext cx="1755720" cy="1317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7" name=""/>
            <p:cNvSpPr/>
            <p:nvPr/>
          </p:nvSpPr>
          <p:spPr>
            <a:xfrm>
              <a:off x="3685680" y="5405400"/>
              <a:ext cx="390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PB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8" name=""/>
          <p:cNvGrpSpPr/>
          <p:nvPr/>
        </p:nvGrpSpPr>
        <p:grpSpPr>
          <a:xfrm>
            <a:off x="517680" y="1125360"/>
            <a:ext cx="1755720" cy="1317600"/>
            <a:chOff x="517680" y="1125360"/>
            <a:chExt cx="1755720" cy="1317600"/>
          </a:xfrm>
        </p:grpSpPr>
        <p:sp>
          <p:nvSpPr>
            <p:cNvPr id="49" name=""/>
            <p:cNvSpPr/>
            <p:nvPr/>
          </p:nvSpPr>
          <p:spPr>
            <a:xfrm>
              <a:off x="1663200" y="1201680"/>
              <a:ext cx="446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wate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0" name="" descr=""/>
            <p:cNvPicPr/>
            <p:nvPr/>
          </p:nvPicPr>
          <p:blipFill>
            <a:blip r:embed="rId3"/>
            <a:stretch/>
          </p:blipFill>
          <p:spPr>
            <a:xfrm>
              <a:off x="517680" y="1125360"/>
              <a:ext cx="1755720" cy="131760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51" name=""/>
          <p:cNvGrpSpPr/>
          <p:nvPr/>
        </p:nvGrpSpPr>
        <p:grpSpPr>
          <a:xfrm>
            <a:off x="517680" y="5329080"/>
            <a:ext cx="1755720" cy="1317600"/>
            <a:chOff x="517680" y="5329080"/>
            <a:chExt cx="1755720" cy="1317600"/>
          </a:xfrm>
        </p:grpSpPr>
        <p:sp>
          <p:nvSpPr>
            <p:cNvPr id="52" name=""/>
            <p:cNvSpPr/>
            <p:nvPr/>
          </p:nvSpPr>
          <p:spPr>
            <a:xfrm>
              <a:off x="1738440" y="5405400"/>
              <a:ext cx="390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PB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3" name="" descr=""/>
            <p:cNvPicPr/>
            <p:nvPr/>
          </p:nvPicPr>
          <p:blipFill>
            <a:blip r:embed="rId4"/>
            <a:stretch/>
          </p:blipFill>
          <p:spPr>
            <a:xfrm>
              <a:off x="517680" y="5329080"/>
              <a:ext cx="1755720" cy="131760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54" name=""/>
          <p:cNvGrpSpPr/>
          <p:nvPr/>
        </p:nvGrpSpPr>
        <p:grpSpPr>
          <a:xfrm>
            <a:off x="4410000" y="5329080"/>
            <a:ext cx="1755720" cy="1317600"/>
            <a:chOff x="4410000" y="5329080"/>
            <a:chExt cx="1755720" cy="1317600"/>
          </a:xfrm>
        </p:grpSpPr>
        <p:pic>
          <p:nvPicPr>
            <p:cNvPr id="55" name="" descr=""/>
            <p:cNvPicPr/>
            <p:nvPr/>
          </p:nvPicPr>
          <p:blipFill>
            <a:blip r:embed="rId5"/>
            <a:stretch/>
          </p:blipFill>
          <p:spPr>
            <a:xfrm>
              <a:off x="4410000" y="5329080"/>
              <a:ext cx="1755720" cy="1317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6" name=""/>
            <p:cNvSpPr/>
            <p:nvPr/>
          </p:nvSpPr>
          <p:spPr>
            <a:xfrm>
              <a:off x="5630760" y="5405040"/>
              <a:ext cx="390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PB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7" name=""/>
          <p:cNvGrpSpPr/>
          <p:nvPr/>
        </p:nvGrpSpPr>
        <p:grpSpPr>
          <a:xfrm>
            <a:off x="4410000" y="1125360"/>
            <a:ext cx="1755720" cy="1317600"/>
            <a:chOff x="4410000" y="1125360"/>
            <a:chExt cx="1755720" cy="1317600"/>
          </a:xfrm>
        </p:grpSpPr>
        <p:sp>
          <p:nvSpPr>
            <p:cNvPr id="58" name=""/>
            <p:cNvSpPr/>
            <p:nvPr/>
          </p:nvSpPr>
          <p:spPr>
            <a:xfrm>
              <a:off x="5555160" y="1201680"/>
              <a:ext cx="446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wate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9" name="" descr=""/>
            <p:cNvPicPr/>
            <p:nvPr/>
          </p:nvPicPr>
          <p:blipFill>
            <a:blip r:embed="rId6"/>
            <a:stretch/>
          </p:blipFill>
          <p:spPr>
            <a:xfrm>
              <a:off x="4410000" y="1125360"/>
              <a:ext cx="1755720" cy="131760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60" name=""/>
          <p:cNvSpPr/>
          <p:nvPr/>
        </p:nvSpPr>
        <p:spPr>
          <a:xfrm>
            <a:off x="1191960" y="890640"/>
            <a:ext cx="52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Arial"/>
              </a:rPr>
              <a:t>Q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2656800" y="890640"/>
            <a:ext cx="1512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Arial"/>
              </a:rPr>
              <a:t>NAC-cap Q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4601520" y="890640"/>
            <a:ext cx="1563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Arial"/>
              </a:rPr>
              <a:t>NAC-conj Q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3" name=""/>
          <p:cNvGraphicFramePr/>
          <p:nvPr/>
        </p:nvGraphicFramePr>
        <p:xfrm>
          <a:off x="343080" y="2556000"/>
          <a:ext cx="6038640" cy="1295280"/>
        </p:xfrm>
        <a:graphic>
          <a:graphicData uri="http://schemas.openxmlformats.org/drawingml/2006/table">
            <a:tbl>
              <a:tblPr/>
              <a:tblGrid>
                <a:gridCol w="1206360"/>
                <a:gridCol w="1208160"/>
                <a:gridCol w="1209600"/>
                <a:gridCol w="1208160"/>
                <a:gridCol w="1206360"/>
              </a:tblGrid>
              <a:tr h="26136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0000"/>
                          </a:solidFill>
                          <a:latin typeface="Arial"/>
                          <a:ea typeface="굴림"/>
                        </a:rPr>
                        <a:t>Wate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굴림"/>
                        </a:rPr>
                        <a:t>0 mi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굴림"/>
                        </a:rPr>
                        <a:t>30 mi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굴림"/>
                        </a:rPr>
                        <a:t>2 h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굴림"/>
                        </a:rPr>
                        <a:t>6 h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2876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굴림"/>
                        </a:rPr>
                        <a:t>Q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굴림"/>
                        </a:rPr>
                        <a:t>542 nm (250 au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굴림"/>
                        </a:rPr>
                        <a:t>542 nm (217 au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굴림"/>
                        </a:rPr>
                        <a:t>542 nm (215 au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굴림"/>
                        </a:rPr>
                        <a:t>541 nm (229 au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42876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굴림"/>
                        </a:rPr>
                        <a:t>NAC-cap Q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굴림"/>
                        </a:rPr>
                        <a:t>524 nm (212 au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굴림"/>
                        </a:rPr>
                        <a:t>525 nm (216 au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굴림"/>
                        </a:rPr>
                        <a:t>525 nm (226 au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굴림"/>
                        </a:rPr>
                        <a:t>524 nm (236 au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2876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굴림"/>
                        </a:rPr>
                        <a:t>NAC-conj Q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굴림"/>
                        </a:rPr>
                        <a:t>526 nm (174 au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굴림"/>
                        </a:rPr>
                        <a:t>526 nm (132 au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굴림"/>
                        </a:rPr>
                        <a:t>526 nm (122 au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굴림"/>
                        </a:rPr>
                        <a:t>525 nm (115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64" name=""/>
          <p:cNvSpPr/>
          <p:nvPr/>
        </p:nvSpPr>
        <p:spPr>
          <a:xfrm>
            <a:off x="1191960" y="5076720"/>
            <a:ext cx="52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Arial"/>
              </a:rPr>
              <a:t>Q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2656800" y="5076720"/>
            <a:ext cx="1512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Arial"/>
              </a:rPr>
              <a:t>NAC-cap Q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4601520" y="5076720"/>
            <a:ext cx="1563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Arial"/>
              </a:rPr>
              <a:t>NAC-conj Q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-720" y="4643280"/>
            <a:ext cx="604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굴림"/>
              </a:rPr>
              <a:t>b)  PL spectra (stability) of CdTe nanoparticles in PB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8" name=""/>
          <p:cNvGraphicFramePr/>
          <p:nvPr/>
        </p:nvGraphicFramePr>
        <p:xfrm>
          <a:off x="339840" y="6804000"/>
          <a:ext cx="6113520" cy="1439640"/>
        </p:xfrm>
        <a:graphic>
          <a:graphicData uri="http://schemas.openxmlformats.org/drawingml/2006/table">
            <a:tbl>
              <a:tblPr/>
              <a:tblGrid>
                <a:gridCol w="1221840"/>
                <a:gridCol w="1222200"/>
                <a:gridCol w="1225080"/>
                <a:gridCol w="1222200"/>
                <a:gridCol w="1222200"/>
              </a:tblGrid>
              <a:tr h="36000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0000"/>
                          </a:solidFill>
                          <a:latin typeface="Arial"/>
                          <a:ea typeface="굴림"/>
                        </a:rPr>
                        <a:t>PB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굴림"/>
                        </a:rPr>
                        <a:t>0 mi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굴림"/>
                        </a:rPr>
                        <a:t>30 mi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굴림"/>
                        </a:rPr>
                        <a:t>2 h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굴림"/>
                        </a:rPr>
                        <a:t>6 h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000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굴림"/>
                        </a:rPr>
                        <a:t>Q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굴림"/>
                        </a:rPr>
                        <a:t>554 nm (65 au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굴림"/>
                        </a:rPr>
                        <a:t>553 nm (68 au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굴림"/>
                        </a:rPr>
                        <a:t>544 nm (73 au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굴림"/>
                        </a:rPr>
                        <a:t>534 nm (62 au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5964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굴림"/>
                        </a:rPr>
                        <a:t>NAC-cap Q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굴림"/>
                        </a:rPr>
                        <a:t>525 nm (240 au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굴림"/>
                        </a:rPr>
                        <a:t>525 nm (229 au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굴림"/>
                        </a:rPr>
                        <a:t>525 nm (252 au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굴림"/>
                        </a:rPr>
                        <a:t>525 nm (246 au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6000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굴림"/>
                        </a:rPr>
                        <a:t>NAC-conj Q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굴림"/>
                        </a:rPr>
                        <a:t>528 nm (145 au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굴림"/>
                        </a:rPr>
                        <a:t>528 nm (129 au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굴림"/>
                        </a:rPr>
                        <a:t>527 nm (121 au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75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굴림"/>
                        </a:rPr>
                        <a:t>524 nm (84 au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1-06T02:17:52Z</dcterms:created>
  <dc:creator>Angela</dc:creator>
  <dc:description/>
  <dc:language>en-US</dc:language>
  <cp:lastModifiedBy>Angela</cp:lastModifiedBy>
  <dcterms:modified xsi:type="dcterms:W3CDTF">2007-02-08T00:01:13Z</dcterms:modified>
  <cp:revision>7</cp:revision>
  <dc:subject/>
  <dc:title>Supplementary Figure 1.</dc:title>
</cp:coreProperties>
</file>